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2" r:id="rId2"/>
    <p:sldId id="263" r:id="rId3"/>
    <p:sldId id="264" r:id="rId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57" d="100"/>
          <a:sy n="57" d="100"/>
        </p:scale>
        <p:origin x="2602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A19F70-5CFE-45FB-B462-588FFE29496F}" type="datetimeFigureOut">
              <a:rPr lang="zh-CN" altLang="en-US" smtClean="0"/>
              <a:t>2025/12/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A0B641-2B26-4F91-8E9C-6E029312D74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565228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A19F70-5CFE-45FB-B462-588FFE29496F}" type="datetimeFigureOut">
              <a:rPr lang="zh-CN" altLang="en-US" smtClean="0"/>
              <a:t>2025/12/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A0B641-2B26-4F91-8E9C-6E029312D74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457379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A19F70-5CFE-45FB-B462-588FFE29496F}" type="datetimeFigureOut">
              <a:rPr lang="zh-CN" altLang="en-US" smtClean="0"/>
              <a:t>2025/12/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A0B641-2B26-4F91-8E9C-6E029312D74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747548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A19F70-5CFE-45FB-B462-588FFE29496F}" type="datetimeFigureOut">
              <a:rPr lang="zh-CN" altLang="en-US" smtClean="0"/>
              <a:t>2025/12/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A0B641-2B26-4F91-8E9C-6E029312D74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14992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A19F70-5CFE-45FB-B462-588FFE29496F}" type="datetimeFigureOut">
              <a:rPr lang="zh-CN" altLang="en-US" smtClean="0"/>
              <a:t>2025/12/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A0B641-2B26-4F91-8E9C-6E029312D74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958487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A19F70-5CFE-45FB-B462-588FFE29496F}" type="datetimeFigureOut">
              <a:rPr lang="zh-CN" altLang="en-US" smtClean="0"/>
              <a:t>2025/12/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A0B641-2B26-4F91-8E9C-6E029312D74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174074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A19F70-5CFE-45FB-B462-588FFE29496F}" type="datetimeFigureOut">
              <a:rPr lang="zh-CN" altLang="en-US" smtClean="0"/>
              <a:t>2025/12/3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A0B641-2B26-4F91-8E9C-6E029312D74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369754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A19F70-5CFE-45FB-B462-588FFE29496F}" type="datetimeFigureOut">
              <a:rPr lang="zh-CN" altLang="en-US" smtClean="0"/>
              <a:t>2025/12/3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A0B641-2B26-4F91-8E9C-6E029312D74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897421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A19F70-5CFE-45FB-B462-588FFE29496F}" type="datetimeFigureOut">
              <a:rPr lang="zh-CN" altLang="en-US" smtClean="0"/>
              <a:t>2025/12/3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A0B641-2B26-4F91-8E9C-6E029312D74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945916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A19F70-5CFE-45FB-B462-588FFE29496F}" type="datetimeFigureOut">
              <a:rPr lang="zh-CN" altLang="en-US" smtClean="0"/>
              <a:t>2025/12/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A0B641-2B26-4F91-8E9C-6E029312D74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513810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A19F70-5CFE-45FB-B462-588FFE29496F}" type="datetimeFigureOut">
              <a:rPr lang="zh-CN" altLang="en-US" smtClean="0"/>
              <a:t>2025/12/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A0B641-2B26-4F91-8E9C-6E029312D74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617080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A19F70-5CFE-45FB-B462-588FFE29496F}" type="datetimeFigureOut">
              <a:rPr lang="zh-CN" altLang="en-US" smtClean="0"/>
              <a:t>2025/12/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A0B641-2B26-4F91-8E9C-6E029312D74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186905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.png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5.png"/><Relationship Id="rId5" Type="http://schemas.openxmlformats.org/officeDocument/2006/relationships/image" Target="../media/image14.png"/><Relationship Id="rId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11C4AF5-CF2A-F6C4-AFB5-66FDC6DDE89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文本框 7">
            <a:extLst>
              <a:ext uri="{FF2B5EF4-FFF2-40B4-BE49-F238E27FC236}">
                <a16:creationId xmlns:a16="http://schemas.microsoft.com/office/drawing/2014/main" id="{F76D4F69-9404-CC71-3B8B-766EDEA4528B}"/>
              </a:ext>
            </a:extLst>
          </p:cNvPr>
          <p:cNvSpPr txBox="1"/>
          <p:nvPr/>
        </p:nvSpPr>
        <p:spPr>
          <a:xfrm>
            <a:off x="1105258" y="607162"/>
            <a:ext cx="37253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A</a:t>
            </a:r>
            <a:endParaRPr lang="zh-CN" altLang="en-US" sz="2000" b="1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2F467A23-77E4-15BE-54B5-5299731D5F9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05258" y="923636"/>
            <a:ext cx="2178921" cy="2178921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CF6DF878-9DFE-7AFA-6F40-347F3D726FF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73821" y="923635"/>
            <a:ext cx="2178921" cy="2178921"/>
          </a:xfrm>
          <a:prstGeom prst="rect">
            <a:avLst/>
          </a:prstGeom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70DDA8ED-49F5-15A3-9DBB-4361D8484DC9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469" y="3355868"/>
            <a:ext cx="2178921" cy="2178921"/>
          </a:xfrm>
          <a:prstGeom prst="rect">
            <a:avLst/>
          </a:pr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4229ECBD-5887-C822-6637-10AC60E15270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39539" y="3355868"/>
            <a:ext cx="2178921" cy="2178921"/>
          </a:xfrm>
          <a:prstGeom prst="rect">
            <a:avLst/>
          </a:prstGeom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id="{1DAF1E79-E10D-1798-D7FC-2AEE3446C132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06480" y="3355868"/>
            <a:ext cx="2178921" cy="2178921"/>
          </a:xfrm>
          <a:prstGeom prst="rect">
            <a:avLst/>
          </a:prstGeom>
        </p:spPr>
      </p:pic>
      <p:sp>
        <p:nvSpPr>
          <p:cNvPr id="19" name="文本框 18">
            <a:extLst>
              <a:ext uri="{FF2B5EF4-FFF2-40B4-BE49-F238E27FC236}">
                <a16:creationId xmlns:a16="http://schemas.microsoft.com/office/drawing/2014/main" id="{8447127A-73BD-0E1F-EA48-646B3B67FE1C}"/>
              </a:ext>
            </a:extLst>
          </p:cNvPr>
          <p:cNvSpPr txBox="1"/>
          <p:nvPr/>
        </p:nvSpPr>
        <p:spPr>
          <a:xfrm>
            <a:off x="3573821" y="607161"/>
            <a:ext cx="37253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B</a:t>
            </a:r>
            <a:endParaRPr lang="zh-CN" altLang="en-US" sz="2000" b="1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C380F676-56C3-BFF6-5ED5-9F824FA60042}"/>
              </a:ext>
            </a:extLst>
          </p:cNvPr>
          <p:cNvSpPr txBox="1"/>
          <p:nvPr/>
        </p:nvSpPr>
        <p:spPr>
          <a:xfrm>
            <a:off x="67469" y="3102556"/>
            <a:ext cx="37253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C</a:t>
            </a:r>
            <a:endParaRPr lang="zh-CN" altLang="en-US" sz="2000" b="1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E75058E1-1534-A11A-5DC3-354AEEEFBCA9}"/>
              </a:ext>
            </a:extLst>
          </p:cNvPr>
          <p:cNvSpPr txBox="1"/>
          <p:nvPr/>
        </p:nvSpPr>
        <p:spPr>
          <a:xfrm>
            <a:off x="2334410" y="3102554"/>
            <a:ext cx="37253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D</a:t>
            </a:r>
            <a:endParaRPr lang="zh-CN" altLang="en-US" sz="2000" b="1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1294A504-7E17-7584-97F4-4569611B6A47}"/>
              </a:ext>
            </a:extLst>
          </p:cNvPr>
          <p:cNvSpPr txBox="1"/>
          <p:nvPr/>
        </p:nvSpPr>
        <p:spPr>
          <a:xfrm>
            <a:off x="4607640" y="3102554"/>
            <a:ext cx="37253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E</a:t>
            </a:r>
            <a:endParaRPr lang="zh-CN" altLang="en-US" sz="2000" b="1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1862C65E-CC35-E6A5-1A4B-05FD0AE25719}"/>
              </a:ext>
            </a:extLst>
          </p:cNvPr>
          <p:cNvSpPr txBox="1"/>
          <p:nvPr/>
        </p:nvSpPr>
        <p:spPr>
          <a:xfrm>
            <a:off x="0" y="-3232"/>
            <a:ext cx="3778624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2400" b="1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Supplementary Figure 1</a:t>
            </a:r>
            <a:endParaRPr lang="zh-CN" altLang="en-US" sz="2400" b="1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1505726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ACB9DC0-A0EC-A88B-08D2-2BA26F49C9F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文本框 7">
            <a:extLst>
              <a:ext uri="{FF2B5EF4-FFF2-40B4-BE49-F238E27FC236}">
                <a16:creationId xmlns:a16="http://schemas.microsoft.com/office/drawing/2014/main" id="{DE8B80B0-612B-C793-A549-030C47F9F0FA}"/>
              </a:ext>
            </a:extLst>
          </p:cNvPr>
          <p:cNvSpPr txBox="1"/>
          <p:nvPr/>
        </p:nvSpPr>
        <p:spPr>
          <a:xfrm>
            <a:off x="1105258" y="593715"/>
            <a:ext cx="37253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A</a:t>
            </a:r>
            <a:endParaRPr lang="zh-CN" altLang="en-US" sz="2000" b="1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EC4F0918-2F59-1F56-3964-EDF30EEC8BDC}"/>
              </a:ext>
            </a:extLst>
          </p:cNvPr>
          <p:cNvSpPr txBox="1"/>
          <p:nvPr/>
        </p:nvSpPr>
        <p:spPr>
          <a:xfrm>
            <a:off x="3573821" y="593714"/>
            <a:ext cx="37253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B</a:t>
            </a:r>
            <a:endParaRPr lang="zh-CN" altLang="en-US" sz="2000" b="1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68B3ED5C-3576-BE0C-4C72-1F1B68A69CFB}"/>
              </a:ext>
            </a:extLst>
          </p:cNvPr>
          <p:cNvSpPr txBox="1"/>
          <p:nvPr/>
        </p:nvSpPr>
        <p:spPr>
          <a:xfrm>
            <a:off x="67469" y="3183238"/>
            <a:ext cx="37253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C</a:t>
            </a:r>
            <a:endParaRPr lang="zh-CN" altLang="en-US" sz="2000" b="1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9405ABFE-6A1B-BC4E-2B74-947F2FF727A4}"/>
              </a:ext>
            </a:extLst>
          </p:cNvPr>
          <p:cNvSpPr txBox="1"/>
          <p:nvPr/>
        </p:nvSpPr>
        <p:spPr>
          <a:xfrm>
            <a:off x="2334410" y="3183236"/>
            <a:ext cx="37253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D</a:t>
            </a:r>
            <a:endParaRPr lang="zh-CN" altLang="en-US" sz="2000" b="1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96E4A5D9-687F-6CEA-298C-30B874AB9774}"/>
              </a:ext>
            </a:extLst>
          </p:cNvPr>
          <p:cNvSpPr txBox="1"/>
          <p:nvPr/>
        </p:nvSpPr>
        <p:spPr>
          <a:xfrm>
            <a:off x="4607640" y="3183236"/>
            <a:ext cx="37253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E</a:t>
            </a:r>
            <a:endParaRPr lang="zh-CN" altLang="en-US" sz="2000" b="1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8DE94EBC-DFF6-C9D8-9F20-6879C969E64B}"/>
              </a:ext>
            </a:extLst>
          </p:cNvPr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1105258" y="923636"/>
            <a:ext cx="2178921" cy="2178921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7EF7D8C7-6A1A-0E52-4B4E-99D0AD84A362}"/>
              </a:ext>
            </a:extLst>
          </p:cNvPr>
          <p:cNvPicPr>
            <a:picLocks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3573821" y="923635"/>
            <a:ext cx="2178921" cy="2178921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60352BD0-9B89-7B7A-BCBF-CCF52DD85145}"/>
              </a:ext>
            </a:extLst>
          </p:cNvPr>
          <p:cNvPicPr>
            <a:picLocks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67469" y="3517232"/>
            <a:ext cx="2178921" cy="2178921"/>
          </a:xfrm>
          <a:prstGeom prst="rect">
            <a:avLst/>
          </a:prstGeom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20314279-A6D0-E1AA-0D17-DE83124D9008}"/>
              </a:ext>
            </a:extLst>
          </p:cNvPr>
          <p:cNvPicPr>
            <a:picLocks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2339539" y="3517232"/>
            <a:ext cx="2178921" cy="2178921"/>
          </a:xfrm>
          <a:prstGeom prst="rect">
            <a:avLst/>
          </a:prstGeom>
        </p:spPr>
      </p:pic>
      <p:pic>
        <p:nvPicPr>
          <p:cNvPr id="24" name="图片 23">
            <a:extLst>
              <a:ext uri="{FF2B5EF4-FFF2-40B4-BE49-F238E27FC236}">
                <a16:creationId xmlns:a16="http://schemas.microsoft.com/office/drawing/2014/main" id="{73B86D8F-FD72-A1ED-A02F-1BB23E16F058}"/>
              </a:ext>
            </a:extLst>
          </p:cNvPr>
          <p:cNvPicPr>
            <a:picLocks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4606480" y="3517232"/>
            <a:ext cx="2178921" cy="2178921"/>
          </a:xfrm>
          <a:prstGeom prst="rect">
            <a:avLst/>
          </a:prstGeom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DD94A8F0-FA5D-DBFF-C27C-DB2095557A6C}"/>
              </a:ext>
            </a:extLst>
          </p:cNvPr>
          <p:cNvSpPr txBox="1"/>
          <p:nvPr/>
        </p:nvSpPr>
        <p:spPr>
          <a:xfrm>
            <a:off x="0" y="0"/>
            <a:ext cx="3778624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2400" b="1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Supplementary Figure 2</a:t>
            </a:r>
            <a:endParaRPr lang="zh-CN" altLang="en-US" sz="2400" b="1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9538040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BC5BA54E-A7BB-21D6-F343-972A5E14454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文本框 7">
            <a:extLst>
              <a:ext uri="{FF2B5EF4-FFF2-40B4-BE49-F238E27FC236}">
                <a16:creationId xmlns:a16="http://schemas.microsoft.com/office/drawing/2014/main" id="{6F2BFCEE-6C77-0728-9D1A-61318E4A61F2}"/>
              </a:ext>
            </a:extLst>
          </p:cNvPr>
          <p:cNvSpPr txBox="1"/>
          <p:nvPr/>
        </p:nvSpPr>
        <p:spPr>
          <a:xfrm>
            <a:off x="1105258" y="607162"/>
            <a:ext cx="37253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A</a:t>
            </a:r>
            <a:endParaRPr lang="zh-CN" altLang="en-US" sz="2000" b="1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4CDBDE9E-C97B-55C7-0580-EA6E6C37EC54}"/>
              </a:ext>
            </a:extLst>
          </p:cNvPr>
          <p:cNvSpPr txBox="1"/>
          <p:nvPr/>
        </p:nvSpPr>
        <p:spPr>
          <a:xfrm>
            <a:off x="3573821" y="607161"/>
            <a:ext cx="37253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B</a:t>
            </a:r>
            <a:endParaRPr lang="zh-CN" altLang="en-US" sz="2000" b="1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7134857A-8EF0-090C-B907-644C2244A381}"/>
              </a:ext>
            </a:extLst>
          </p:cNvPr>
          <p:cNvSpPr txBox="1"/>
          <p:nvPr/>
        </p:nvSpPr>
        <p:spPr>
          <a:xfrm>
            <a:off x="67469" y="3196685"/>
            <a:ext cx="37253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C</a:t>
            </a:r>
            <a:endParaRPr lang="zh-CN" altLang="en-US" sz="2000" b="1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442F2247-E720-FA39-48B0-341F95B063C8}"/>
              </a:ext>
            </a:extLst>
          </p:cNvPr>
          <p:cNvSpPr txBox="1"/>
          <p:nvPr/>
        </p:nvSpPr>
        <p:spPr>
          <a:xfrm>
            <a:off x="2334410" y="3196683"/>
            <a:ext cx="37253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D</a:t>
            </a:r>
            <a:endParaRPr lang="zh-CN" altLang="en-US" sz="2000" b="1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5BC9345C-7050-1E87-A8AD-96BC2765F9DE}"/>
              </a:ext>
            </a:extLst>
          </p:cNvPr>
          <p:cNvSpPr txBox="1"/>
          <p:nvPr/>
        </p:nvSpPr>
        <p:spPr>
          <a:xfrm>
            <a:off x="4607640" y="3196683"/>
            <a:ext cx="37253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E</a:t>
            </a:r>
            <a:endParaRPr lang="zh-CN" altLang="en-US" sz="2000" b="1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AE4B701B-E27C-0445-939B-73FE4F6B63BD}"/>
              </a:ext>
            </a:extLst>
          </p:cNvPr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1105258" y="923636"/>
            <a:ext cx="2178921" cy="2178921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B174E0A9-50BB-082E-0961-1FD30F1CD193}"/>
              </a:ext>
            </a:extLst>
          </p:cNvPr>
          <p:cNvPicPr>
            <a:picLocks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3573821" y="923635"/>
            <a:ext cx="2178921" cy="2178921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F7A911AA-38CE-6FF2-B068-40B60E9B17D8}"/>
              </a:ext>
            </a:extLst>
          </p:cNvPr>
          <p:cNvPicPr>
            <a:picLocks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67469" y="3503785"/>
            <a:ext cx="2178921" cy="2178921"/>
          </a:xfrm>
          <a:prstGeom prst="rect">
            <a:avLst/>
          </a:prstGeom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E3AE4EA5-4F0F-653A-C28D-692CFE2FBBD4}"/>
              </a:ext>
            </a:extLst>
          </p:cNvPr>
          <p:cNvPicPr>
            <a:picLocks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2339539" y="3503785"/>
            <a:ext cx="2178921" cy="2178921"/>
          </a:xfrm>
          <a:prstGeom prst="rect">
            <a:avLst/>
          </a:pr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F934FB16-4E76-CC88-8112-0B7477A37505}"/>
              </a:ext>
            </a:extLst>
          </p:cNvPr>
          <p:cNvPicPr>
            <a:picLocks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4606480" y="3503785"/>
            <a:ext cx="2178921" cy="2178921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650BBE65-5FAE-D560-9F84-CA33DB5D4012}"/>
              </a:ext>
            </a:extLst>
          </p:cNvPr>
          <p:cNvSpPr txBox="1"/>
          <p:nvPr/>
        </p:nvSpPr>
        <p:spPr>
          <a:xfrm>
            <a:off x="-1" y="-3232"/>
            <a:ext cx="3832413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2400" b="1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Supplementary Figure 3</a:t>
            </a:r>
            <a:endParaRPr lang="zh-CN" altLang="en-US" sz="2400" b="1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682547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471</TotalTime>
  <Words>24</Words>
  <Application>Microsoft Office PowerPoint</Application>
  <PresentationFormat>A4 纸张(210x297 毫米)</PresentationFormat>
  <Paragraphs>18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主题​​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indows 用户</dc:creator>
  <cp:lastModifiedBy>Hang Xing</cp:lastModifiedBy>
  <cp:revision>14</cp:revision>
  <dcterms:created xsi:type="dcterms:W3CDTF">2025-09-24T08:14:26Z</dcterms:created>
  <dcterms:modified xsi:type="dcterms:W3CDTF">2025-12-03T16:05:41Z</dcterms:modified>
</cp:coreProperties>
</file>